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9" autoAdjust="0"/>
    <p:restoredTop sz="94660"/>
  </p:normalViewPr>
  <p:slideViewPr>
    <p:cSldViewPr snapToGrid="0">
      <p:cViewPr varScale="1">
        <p:scale>
          <a:sx n="68" d="100"/>
          <a:sy n="68" d="100"/>
        </p:scale>
        <p:origin x="282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A45E-A654-49B0-9754-1E918FE34942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08E0-DD1E-4723-94B8-726E4FF7FC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2176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A45E-A654-49B0-9754-1E918FE34942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08E0-DD1E-4723-94B8-726E4FF7FC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2100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A45E-A654-49B0-9754-1E918FE34942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08E0-DD1E-4723-94B8-726E4FF7FC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789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A45E-A654-49B0-9754-1E918FE34942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08E0-DD1E-4723-94B8-726E4FF7FC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7587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A45E-A654-49B0-9754-1E918FE34942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08E0-DD1E-4723-94B8-726E4FF7FC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583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A45E-A654-49B0-9754-1E918FE34942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08E0-DD1E-4723-94B8-726E4FF7FC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057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A45E-A654-49B0-9754-1E918FE34942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08E0-DD1E-4723-94B8-726E4FF7FC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017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A45E-A654-49B0-9754-1E918FE34942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08E0-DD1E-4723-94B8-726E4FF7FC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690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A45E-A654-49B0-9754-1E918FE34942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08E0-DD1E-4723-94B8-726E4FF7FC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399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A45E-A654-49B0-9754-1E918FE34942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08E0-DD1E-4723-94B8-726E4FF7FC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1578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CCA45E-A654-49B0-9754-1E918FE34942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C208E0-DD1E-4723-94B8-726E4FF7FC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596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CCA45E-A654-49B0-9754-1E918FE34942}" type="datetimeFigureOut">
              <a:rPr lang="en-US" smtClean="0"/>
              <a:t>5/25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C208E0-DD1E-4723-94B8-726E4FF7FC4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320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mp4"/><Relationship Id="rId7" Type="http://schemas.openxmlformats.org/officeDocument/2006/relationships/slideLayout" Target="../slideLayouts/slideLayout2.xml"/><Relationship Id="rId12" Type="http://schemas.openxmlformats.org/officeDocument/2006/relationships/image" Target="../media/image5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4.png"/><Relationship Id="rId5" Type="http://schemas.microsoft.com/office/2007/relationships/media" Target="../media/media3.mp4"/><Relationship Id="rId10" Type="http://schemas.openxmlformats.org/officeDocument/2006/relationships/image" Target="../media/image3.png"/><Relationship Id="rId4" Type="http://schemas.openxmlformats.org/officeDocument/2006/relationships/video" Target="../media/media2.mp4"/><Relationship Id="rId9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/>
          <p:cNvGrpSpPr/>
          <p:nvPr/>
        </p:nvGrpSpPr>
        <p:grpSpPr>
          <a:xfrm>
            <a:off x="425279" y="454127"/>
            <a:ext cx="6175050" cy="2005285"/>
            <a:chOff x="352367" y="257434"/>
            <a:chExt cx="6175050" cy="2005285"/>
          </a:xfrm>
        </p:grpSpPr>
        <p:pic>
          <p:nvPicPr>
            <p:cNvPr id="4" name="0AC9F9B">
              <a:hlinkClick r:id="" action="ppaction://media"/>
            </p:cNvPr>
            <p:cNvPicPr>
              <a:picLocks noChangeAspect="1"/>
            </p:cNvPicPr>
            <p:nvPr>
              <a:videoFile r:link="rId6"/>
              <p:extLst>
                <p:ext uri="{DAA4B4D4-6D71-4841-9C94-3DE7FCFB9230}">
                  <p14:media xmlns:p14="http://schemas.microsoft.com/office/powerpoint/2010/main" r:embed="rId5"/>
                </p:ext>
              </p:extLst>
            </p:nvPr>
          </p:nvPicPr>
          <p:blipFill>
            <a:blip r:embed="rId8"/>
            <a:stretch>
              <a:fillRect/>
            </a:stretch>
          </p:blipFill>
          <p:spPr>
            <a:xfrm>
              <a:off x="449861" y="1003652"/>
              <a:ext cx="5839152" cy="1259067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643795" y="665008"/>
              <a:ext cx="712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574368" y="665008"/>
              <a:ext cx="8418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oechst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666214" y="665008"/>
              <a:ext cx="7825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emp1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698749" y="665008"/>
              <a:ext cx="6014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ap2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550145" y="665008"/>
              <a:ext cx="7385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Ter119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228665" y="454127"/>
              <a:ext cx="1298752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emp1/Lap2/</a:t>
              </a:r>
            </a:p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oechst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43948AC-6218-FA41-9766-0609410AFD2B}"/>
                </a:ext>
              </a:extLst>
            </p:cNvPr>
            <p:cNvSpPr txBox="1"/>
            <p:nvPr/>
          </p:nvSpPr>
          <p:spPr>
            <a:xfrm>
              <a:off x="352367" y="257434"/>
              <a:ext cx="122200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Video S1</a:t>
              </a:r>
            </a:p>
          </p:txBody>
        </p:sp>
      </p:grpSp>
      <p:grpSp>
        <p:nvGrpSpPr>
          <p:cNvPr id="35" name="Group 34"/>
          <p:cNvGrpSpPr/>
          <p:nvPr/>
        </p:nvGrpSpPr>
        <p:grpSpPr>
          <a:xfrm>
            <a:off x="400697" y="2681067"/>
            <a:ext cx="5951098" cy="3011780"/>
            <a:chOff x="352367" y="2826477"/>
            <a:chExt cx="5951098" cy="3011780"/>
          </a:xfrm>
        </p:grpSpPr>
        <p:pic>
          <p:nvPicPr>
            <p:cNvPr id="13" name="41441D3">
              <a:hlinkClick r:id="" action="ppaction://media"/>
            </p:cNvPr>
            <p:cNvPicPr>
              <a:picLocks noChangeAspect="1"/>
            </p:cNvPicPr>
            <p:nvPr>
              <a:videoFile r:link="rId4"/>
              <p:extLst>
                <p:ext uri="{DAA4B4D4-6D71-4841-9C94-3DE7FCFB9230}">
                  <p14:media xmlns:p14="http://schemas.microsoft.com/office/powerpoint/2010/main" r:embed="rId3"/>
                </p:ext>
              </p:extLst>
            </p:nvPr>
          </p:nvPicPr>
          <p:blipFill>
            <a:blip r:embed="rId9"/>
            <a:stretch>
              <a:fillRect/>
            </a:stretch>
          </p:blipFill>
          <p:spPr>
            <a:xfrm>
              <a:off x="449861" y="3571695"/>
              <a:ext cx="5853604" cy="1060965"/>
            </a:xfrm>
            <a:prstGeom prst="rect">
              <a:avLst/>
            </a:prstGeom>
          </p:spPr>
        </p:pic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49861" y="4891511"/>
              <a:ext cx="5839152" cy="638969"/>
            </a:xfrm>
            <a:prstGeom prst="rect">
              <a:avLst/>
            </a:prstGeom>
          </p:spPr>
        </p:pic>
        <p:sp>
          <p:nvSpPr>
            <p:cNvPr id="21" name="TextBox 20"/>
            <p:cNvSpPr txBox="1"/>
            <p:nvPr/>
          </p:nvSpPr>
          <p:spPr>
            <a:xfrm>
              <a:off x="559595" y="3251892"/>
              <a:ext cx="712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715361" y="3251892"/>
              <a:ext cx="8418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oechst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975147" y="3251892"/>
              <a:ext cx="7825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emp1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141914" y="3251892"/>
              <a:ext cx="6014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ap2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039952" y="3251892"/>
              <a:ext cx="12490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emp1/Lap2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43948AC-6218-FA41-9766-0609410AFD2B}"/>
                </a:ext>
              </a:extLst>
            </p:cNvPr>
            <p:cNvSpPr txBox="1"/>
            <p:nvPr/>
          </p:nvSpPr>
          <p:spPr>
            <a:xfrm>
              <a:off x="352367" y="2826477"/>
              <a:ext cx="122200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Video S2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801347" y="5530480"/>
              <a:ext cx="31361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Thresholded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confocal </a:t>
              </a:r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midplane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6" name="Group 35"/>
          <p:cNvGrpSpPr/>
          <p:nvPr/>
        </p:nvGrpSpPr>
        <p:grpSpPr>
          <a:xfrm>
            <a:off x="425279" y="5815991"/>
            <a:ext cx="6094927" cy="2888106"/>
            <a:chOff x="352367" y="6063435"/>
            <a:chExt cx="6094927" cy="2888106"/>
          </a:xfrm>
        </p:grpSpPr>
        <p:pic>
          <p:nvPicPr>
            <p:cNvPr id="14" name="C482AC5">
              <a:hlinkClick r:id="" action="ppaction://media"/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11"/>
            <a:stretch>
              <a:fillRect/>
            </a:stretch>
          </p:blipFill>
          <p:spPr>
            <a:xfrm>
              <a:off x="449861" y="6771322"/>
              <a:ext cx="5839151" cy="1107006"/>
            </a:xfrm>
            <a:prstGeom prst="rect">
              <a:avLst/>
            </a:prstGeom>
          </p:spPr>
        </p:pic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449861" y="8166243"/>
              <a:ext cx="5853604" cy="497383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1781449" y="8643764"/>
              <a:ext cx="313617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Thresholded</a:t>
              </a:r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 confocal </a:t>
              </a:r>
              <a:r>
                <a:rPr lang="en-US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midplane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243948AC-6218-FA41-9766-0609410AFD2B}"/>
                </a:ext>
              </a:extLst>
            </p:cNvPr>
            <p:cNvSpPr txBox="1"/>
            <p:nvPr/>
          </p:nvSpPr>
          <p:spPr>
            <a:xfrm>
              <a:off x="352367" y="6063435"/>
              <a:ext cx="1222001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>
                  <a:latin typeface="Arial" panose="020B0604020202020204" pitchFamily="34" charset="0"/>
                  <a:cs typeface="Arial" panose="020B0604020202020204" pitchFamily="34" charset="0"/>
                </a:rPr>
                <a:t>Video S3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17877" y="6463545"/>
              <a:ext cx="7120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873643" y="6463545"/>
              <a:ext cx="84189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Hoechst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133429" y="6463545"/>
              <a:ext cx="78258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emp1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300196" y="6463545"/>
              <a:ext cx="60144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Lap2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198234" y="6463545"/>
              <a:ext cx="12490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Nemp1/Lap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822551879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3" fill="hold" display="0">
                  <p:stCondLst>
                    <p:cond delay="indefinite"/>
                  </p:stCondLst>
                </p:cTn>
                <p:tgtEl>
                  <p:spTgt spid="13"/>
                </p:tgtEl>
              </p:cMediaNode>
            </p:video>
            <p:video>
              <p:cMediaNode vol="80000">
                <p:cTn id="4" fill="hold" display="0">
                  <p:stCondLst>
                    <p:cond delay="indefinite"/>
                  </p:stCondLst>
                </p:cTn>
                <p:tgtEl>
                  <p:spTgt spid="1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0</Words>
  <Application>Microsoft Office PowerPoint</Application>
  <PresentationFormat>Letter Paper (8.5x11 in)</PresentationFormat>
  <Paragraphs>22</Paragraphs>
  <Slides>1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Washington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odzic, Didier</dc:creator>
  <cp:lastModifiedBy>Hodzic, Didier</cp:lastModifiedBy>
  <cp:revision>1</cp:revision>
  <dcterms:created xsi:type="dcterms:W3CDTF">2022-05-25T21:25:46Z</dcterms:created>
  <dcterms:modified xsi:type="dcterms:W3CDTF">2022-05-25T21:26:32Z</dcterms:modified>
</cp:coreProperties>
</file>